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36960" cy="463680"/>
          </a:xfrm>
          <a:prstGeom prst="rect">
            <a:avLst/>
          </a:prstGeom>
          <a:noFill/>
          <a:ln w="0">
            <a:noFill/>
          </a:ln>
        </p:spPr>
        <p:txBody>
          <a:bodyPr lIns="90720" rIns="90720" tIns="45360" bIns="4536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71880" y="0"/>
            <a:ext cx="3036960" cy="463680"/>
          </a:xfrm>
          <a:prstGeom prst="rect">
            <a:avLst/>
          </a:prstGeom>
          <a:noFill/>
          <a:ln w="0">
            <a:noFill/>
          </a:ln>
        </p:spPr>
        <p:txBody>
          <a:bodyPr lIns="90720" rIns="90720" tIns="45360" bIns="4536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79000" y="696960"/>
            <a:ext cx="4651560" cy="3487680"/>
          </a:xfrm>
          <a:prstGeom prst="rect">
            <a:avLst/>
          </a:prstGeom>
          <a:noFill/>
          <a:ln w="12600">
            <a:solidFill>
              <a:srgbClr val="000000"/>
            </a:solidFill>
            <a:miter/>
          </a:ln>
        </p:spPr>
        <p:txBody>
          <a:bodyPr lIns="90720" rIns="90720" tIns="45360" bIns="453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31160"/>
            <a:ext cx="3036960" cy="463680"/>
          </a:xfrm>
          <a:prstGeom prst="rect">
            <a:avLst/>
          </a:prstGeom>
          <a:noFill/>
          <a:ln w="0">
            <a:noFill/>
          </a:ln>
        </p:spPr>
        <p:txBody>
          <a:bodyPr lIns="90720" rIns="90720" tIns="45360" bIns="4536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71880" y="8831160"/>
            <a:ext cx="3036960" cy="463680"/>
          </a:xfrm>
          <a:prstGeom prst="rect">
            <a:avLst/>
          </a:prstGeom>
          <a:noFill/>
          <a:ln w="0">
            <a:noFill/>
          </a:ln>
        </p:spPr>
        <p:txBody>
          <a:bodyPr lIns="90720" rIns="90720" tIns="45360" bIns="4536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484193A-2D2F-4878-A749-D9C2AA6A5903}"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179360" y="696960"/>
            <a:ext cx="4651560" cy="3487680"/>
          </a:xfrm>
          <a:prstGeom prst="rect">
            <a:avLst/>
          </a:prstGeom>
          <a:ln w="0">
            <a:noFill/>
          </a:ln>
        </p:spPr>
      </p:sp>
      <p:sp>
        <p:nvSpPr>
          <p:cNvPr id="53" name="PlaceHolder 2"/>
          <p:cNvSpPr>
            <a:spLocks noGrp="1"/>
          </p:cNvSpPr>
          <p:nvPr>
            <p:ph type="body"/>
          </p:nvPr>
        </p:nvSpPr>
        <p:spPr>
          <a:xfrm>
            <a:off x="701280" y="4416120"/>
            <a:ext cx="560700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4" name="Slide Number Placeholder 3"/>
          <p:cNvSpPr/>
          <p:nvPr/>
        </p:nvSpPr>
        <p:spPr>
          <a:xfrm>
            <a:off x="3971880" y="8831160"/>
            <a:ext cx="3036960" cy="463680"/>
          </a:xfrm>
          <a:prstGeom prst="rect">
            <a:avLst/>
          </a:prstGeom>
          <a:noFill/>
          <a:ln w="0">
            <a:noFill/>
          </a:ln>
        </p:spPr>
        <p:style>
          <a:lnRef idx="0"/>
          <a:fillRef idx="0"/>
          <a:effectRef idx="0"/>
          <a:fontRef idx="minor"/>
        </p:style>
        <p:txBody>
          <a:bodyPr lIns="90720" rIns="90720" tIns="45360" bIns="453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349C26C-0E53-45BA-AC63-05EC68626C8E}"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B63C1E8-34EE-44FB-BB7E-5D047F801D4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F1B98CB-A6B4-482A-9C79-199FDA6BC5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FDB0817-4988-4ED4-ABD1-6208C2E7463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DFA726C-AE85-47DE-B26C-A4FFF43E7B5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01CDD6-D628-4284-91D1-AF5C968374E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3DE934-F775-472E-9369-90D344D74A4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54F53B0-36EE-479F-803D-F27565882C0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8A7D2AC-A8C9-4E16-8C2F-4922838DD82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E0BF046-4AA8-4EF2-B8B9-5896435E2A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8D223B-66D4-4DB1-AAC2-BA589F67EC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1B15EC3-768E-4856-80C8-52066DE025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C3D57C1-C3C7-4F9E-B2DD-4DBC208CA22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340C6B-A5A7-4133-9EDA-F05EB69B5FD0}"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Slide Number Placeholder 2"/>
          <p:cNvSpPr/>
          <p:nvPr/>
        </p:nvSpPr>
        <p:spPr>
          <a:xfrm>
            <a:off x="6553080" y="6356520"/>
            <a:ext cx="2133720" cy="365040"/>
          </a:xfrm>
          <a:prstGeom prst="rect">
            <a:avLst/>
          </a:prstGeom>
          <a:noFill/>
          <a:ln w="0">
            <a:noFill/>
          </a:ln>
        </p:spPr>
        <p:style>
          <a:lnRef idx="0"/>
          <a:fillRef idx="0"/>
          <a:effectRef idx="0"/>
          <a:fontRef idx="minor"/>
        </p:style>
        <p:txBody>
          <a:bodyPr lIns="90000" rIns="90000" tIns="46800" bIns="46800" anchor="ctr">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3E8CED9-51D9-4825-81F1-EB7EAF98A0A0}"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graphicFrame>
        <p:nvGraphicFramePr>
          <p:cNvPr id="49" name=""/>
          <p:cNvGraphicFramePr/>
          <p:nvPr/>
        </p:nvGraphicFramePr>
        <p:xfrm>
          <a:off x="152280" y="800280"/>
          <a:ext cx="8763120" cy="4778280"/>
        </p:xfrm>
        <a:graphic>
          <a:graphicData uri="http://schemas.openxmlformats.org/drawingml/2006/table">
            <a:tbl>
              <a:tblPr/>
              <a:tblGrid>
                <a:gridCol w="403200"/>
                <a:gridCol w="2135160"/>
                <a:gridCol w="673200"/>
                <a:gridCol w="673200"/>
                <a:gridCol w="531720"/>
                <a:gridCol w="530280"/>
                <a:gridCol w="558720"/>
                <a:gridCol w="673200"/>
                <a:gridCol w="480960"/>
                <a:gridCol w="480960"/>
                <a:gridCol w="1622520"/>
              </a:tblGrid>
              <a:tr h="49032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Gene</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ull Name</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sotyp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ti-PD-L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Paired Wilcoxon </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old Change</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Median)</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sotyp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ti-PD-L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Paired Wilcoxon </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old Change (Median)</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notation</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922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D40LG</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luster of differentiation 40 Ligand</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44</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3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5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4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6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04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6</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mmune Inhibitor</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L6R</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leukin 6 receptor</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68</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00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5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1.72</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6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06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2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Receptor for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leukin 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840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IRAP</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oll-interleukin 1 receptor (TIR) domai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ontaining adaptor protein </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2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12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1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59</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7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667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2</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dapter protein for TLR4 signaling pathway</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8396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D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luster of differentiation 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9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5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7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08</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0.6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7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252</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08</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4</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TGAM</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grin alpha M, CD11b</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10</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1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0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81</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5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6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575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Mediates inflammation by leukocyte adhesion</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3794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ELK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ETS domain-containing protein 1</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28</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10</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34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7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84</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8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8852</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ranscription factor, potentially involved in IL-6 signaling, component of MAPK pathway</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858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HAVCR2</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800" spc="-1" strike="noStrike">
                          <a:solidFill>
                            <a:srgbClr val="000000"/>
                          </a:solidFill>
                          <a:latin typeface="Calibri"/>
                        </a:rPr>
                        <a:t>Hepatitis A Virus Cellular Receptor 2</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800" spc="-1" strike="noStrike">
                          <a:solidFill>
                            <a:srgbClr val="000000"/>
                          </a:solidFill>
                          <a:latin typeface="Calibri"/>
                        </a:rPr>
                        <a:t> </a:t>
                      </a:r>
                      <a:r>
                        <a:rPr b="0" lang="pt-BR" sz="800" spc="-1" strike="noStrike">
                          <a:solidFill>
                            <a:srgbClr val="000000"/>
                          </a:solidFill>
                          <a:latin typeface="Calibri"/>
                        </a:rPr>
                        <a:t>(TIM-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0.20</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8.3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17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42</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3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5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243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H-1 cell surface protein that regulates exhaustion</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858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XCR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X-C chemokine receptor type 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0.01</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6.3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580</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28</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1.6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9.2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255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9</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Calibri"/>
                        </a:rPr>
                        <a:t>Adaptive immune response,  chemokines , T-cell polarization</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904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NF</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umor necrosis factor</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5.76</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9.00</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34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27</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39</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0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453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0</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Humoral immune respons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858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SG1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feron-stimulated gene 1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07</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2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122</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1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17</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1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43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6</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feron stimulated gene, component of anti-viral respons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8396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P5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umor protein p5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6.1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6.4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59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2.40</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1.9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482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cell proliferation, P5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4730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D9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dhesion G protein-coupled receptor E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14.10</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8.8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56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5.12</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9.1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325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6</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romote adhesion and migration to sites of inflammation, involved in ADCC dependent granulocyte releas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3794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GNLY</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Granulysin (LAG-2)</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7.07</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6.67</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73</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0</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1.27</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8.5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4479</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daptive immune response, cell type specific, Cytotoxicity, LAG-2</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922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STAT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ignal transducer and activator of transcription 6</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6.24</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6.58</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698</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7.08</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5.0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840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2</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daptive immune response, TH2</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2858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CL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hemokine (C-C motif) ligand 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4.82</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82.92</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30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5</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3.41</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8.9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26</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8</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ytokines and receptors, Chronic inflammatory respons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r h="190440">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RAK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leukin-1 receptor-associated kinase 1</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5.63</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05</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34</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4</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1.19</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7.68</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222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3</a:t>
                      </a:r>
                      <a:endParaRPr b="0" lang="en-US" sz="800" spc="-1" strike="noStrike">
                        <a:solidFill>
                          <a:srgbClr val="000000"/>
                        </a:solidFill>
                        <a:latin typeface="Calibri"/>
                      </a:endParaRPr>
                    </a:p>
                  </a:txBody>
                  <a:tcPr anchor="ctr" marL="3600" marR="360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otentiates activaition of IL-1 targets</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0" name="TextBox 1"/>
          <p:cNvSpPr/>
          <p:nvPr/>
        </p:nvSpPr>
        <p:spPr>
          <a:xfrm>
            <a:off x="152280" y="5638680"/>
            <a:ext cx="876312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Arial"/>
              </a:rPr>
              <a:t>Notable immune-related genes identified with trends of differential expression (</a:t>
            </a:r>
            <a:r>
              <a:rPr b="0" i="1" lang="en-US" sz="1200" spc="-1" strike="noStrike">
                <a:solidFill>
                  <a:srgbClr val="000000"/>
                </a:solidFill>
                <a:latin typeface="Calibri"/>
                <a:ea typeface="Arial"/>
              </a:rPr>
              <a:t>P</a:t>
            </a:r>
            <a:r>
              <a:rPr b="0" lang="en-US" sz="1200" spc="-1" strike="noStrike">
                <a:solidFill>
                  <a:srgbClr val="000000"/>
                </a:solidFill>
                <a:latin typeface="Calibri"/>
                <a:ea typeface="Arial"/>
              </a:rPr>
              <a:t> &lt; 0.1 and sorted by fold change) between peripheral blood mononuclear cells (PBMCs) of healthy donors stimulated with CEFT (containing peptides encoding for cytomegalovirus , Epstein-Barr virus, Flu, and tetanus toxin ) and treated with avelumab relative to the isotype control.  Values for PBMCs stimulated with negative control peptide pool, human leukocyte antigen (HLA), and treated with avelumab or the isotype control are also shown. Includes gene name, full name, </a:t>
            </a:r>
            <a:r>
              <a:rPr b="0" i="1" lang="en-US" sz="1200" spc="-1" strike="noStrike">
                <a:solidFill>
                  <a:srgbClr val="000000"/>
                </a:solidFill>
                <a:latin typeface="Calibri"/>
                <a:ea typeface="Arial"/>
              </a:rPr>
              <a:t>P</a:t>
            </a:r>
            <a:r>
              <a:rPr b="0" lang="en-US" sz="1200" spc="-1" strike="noStrike">
                <a:solidFill>
                  <a:srgbClr val="000000"/>
                </a:solidFill>
                <a:latin typeface="Calibri"/>
                <a:ea typeface="Arial"/>
              </a:rPr>
              <a:t> value, fold change, and annotated function.</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1" name="Title 1"/>
          <p:cNvSpPr/>
          <p:nvPr/>
        </p:nvSpPr>
        <p:spPr>
          <a:xfrm>
            <a:off x="76320" y="76320"/>
            <a:ext cx="8534160" cy="609480"/>
          </a:xfrm>
          <a:prstGeom prst="rect">
            <a:avLst/>
          </a:prstGeom>
          <a:noFill/>
          <a:ln w="0">
            <a:noFill/>
          </a:ln>
        </p:spPr>
        <p:style>
          <a:lnRef idx="0"/>
          <a:fillRef idx="0"/>
          <a:effectRef idx="0"/>
          <a:fontRef idx="minor"/>
        </p:style>
        <p:txBody>
          <a:bodyPr lIns="90000" rIns="90000" tIns="46800" bIns="46800" anchor="ctr">
            <a:normAutofit fontScale="94000"/>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ea typeface="Arial"/>
              </a:rPr>
              <a:t>Supplementary Table 1</a:t>
            </a:r>
            <a:br>
              <a:rPr sz="1400"/>
            </a:br>
            <a:r>
              <a:rPr b="1" lang="en-US" sz="1200" spc="-1" strike="noStrike">
                <a:solidFill>
                  <a:srgbClr val="000000"/>
                </a:solidFill>
                <a:latin typeface="Calibri"/>
                <a:ea typeface="Arial"/>
              </a:rPr>
              <a:t>Downregulated genes in PBMCs from healthy donors stimulated with CEFT or HLA peptide pools and treated with anti-PD-L1 (avelumab) compared to the isotype control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4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23T20:58:24Z</dcterms:created>
  <dc:creator>Grenga, Italia (NIH/NCI) [F]</dc:creator>
  <dc:description/>
  <dc:language>en-US</dc:language>
  <cp:lastModifiedBy>Weingarten, Debra (NIH/NCI) [E]</cp:lastModifiedBy>
  <cp:lastPrinted>2016-03-29T19:01:22Z</cp:lastPrinted>
  <dcterms:modified xsi:type="dcterms:W3CDTF">2016-04-06T19:06:37Z</dcterms:modified>
  <cp:revision>147</cp:revision>
  <dc:subject/>
  <dc:title>Comparison between EMD Serono a-PDL1 and commercially available a-PDL1</dc:title>
</cp:coreProperties>
</file>